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139" d="100"/>
          <a:sy n="139" d="100"/>
        </p:scale>
        <p:origin x="-2124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D4F22-2EC9-43FA-BA7A-4BD75B1020D4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9/2/12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83077-982F-43C8-A22A-9D7F7C6BCFC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306607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D4F22-2EC9-43FA-BA7A-4BD75B1020D4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9/2/12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83077-982F-43C8-A22A-9D7F7C6BCFC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201817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D4F22-2EC9-43FA-BA7A-4BD75B1020D4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9/2/12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83077-982F-43C8-A22A-9D7F7C6BCFC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585437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D4F22-2EC9-43FA-BA7A-4BD75B1020D4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9/2/12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83077-982F-43C8-A22A-9D7F7C6BCFC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35446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2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D4F22-2EC9-43FA-BA7A-4BD75B1020D4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9/2/12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83077-982F-43C8-A22A-9D7F7C6BCFC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833042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D4F22-2EC9-43FA-BA7A-4BD75B1020D4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9/2/12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83077-982F-43C8-A22A-9D7F7C6BCFC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057157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D4F22-2EC9-43FA-BA7A-4BD75B1020D4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9/2/12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83077-982F-43C8-A22A-9D7F7C6BCFC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875468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D4F22-2EC9-43FA-BA7A-4BD75B1020D4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9/2/12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83077-982F-43C8-A22A-9D7F7C6BCFC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664722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D4F22-2EC9-43FA-BA7A-4BD75B1020D4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9/2/12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83077-982F-43C8-A22A-9D7F7C6BCFC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156354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2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1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D4F22-2EC9-43FA-BA7A-4BD75B1020D4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9/2/12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83077-982F-43C8-A22A-9D7F7C6BCFC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702080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D4F22-2EC9-43FA-BA7A-4BD75B1020D4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9/2/12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83077-982F-43C8-A22A-9D7F7C6BCFC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079694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2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DD4F22-2EC9-43FA-BA7A-4BD75B1020D4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9/2/12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2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483077-982F-43C8-A22A-9D7F7C6BCFC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706379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99324" y="1038577"/>
            <a:ext cx="8177517" cy="466132"/>
          </a:xfrm>
        </p:spPr>
        <p:txBody>
          <a:bodyPr anchor="t">
            <a:normAutofit fontScale="90000"/>
          </a:bodyPr>
          <a:lstStyle/>
          <a:p>
            <a:pPr lvl="0" algn="l" fontAlgn="ctr">
              <a:spcBef>
                <a:spcPts val="0"/>
              </a:spcBef>
              <a:defRPr/>
            </a:pPr>
            <a:r>
              <a:rPr lang="en-US" altLang="ja-JP" sz="1800" b="1" i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upplementary Table </a:t>
            </a:r>
            <a:r>
              <a:rPr lang="en-US" altLang="ja-JP" sz="1800" b="1" i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1. Characteristics of chromaticity, delta and Michelson contrast</a:t>
            </a:r>
            <a:r>
              <a:rPr lang="en-US" altLang="ja-JP" sz="1800" b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/>
            </a:r>
            <a:br>
              <a:rPr lang="en-US" altLang="ja-JP" sz="1800" b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</a:br>
            <a:r>
              <a:rPr lang="en-US" altLang="ja-JP" sz="1800" b="1" i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/>
            </a:r>
            <a:br>
              <a:rPr lang="en-US" altLang="ja-JP" sz="1800" b="1" i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</a:br>
            <a:r>
              <a:rPr lang="en-US" altLang="ja-JP" sz="1600" b="1" i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/>
            </a:r>
            <a:br>
              <a:rPr lang="en-US" altLang="ja-JP" sz="1600" b="1" i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</a:br>
            <a:r>
              <a:rPr lang="ja-JP" altLang="ja-JP" dirty="0" smtClean="0"/>
              <a:t/>
            </a:r>
            <a:br>
              <a:rPr lang="ja-JP" altLang="ja-JP" dirty="0" smtClean="0"/>
            </a:br>
            <a:endParaRPr kumimoji="1" lang="ja-JP" altLang="en-US" dirty="0"/>
          </a:p>
        </p:txBody>
      </p:sp>
      <p:graphicFrame>
        <p:nvGraphicFramePr>
          <p:cNvPr id="3" name="表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66912356"/>
              </p:ext>
            </p:extLst>
          </p:nvPr>
        </p:nvGraphicFramePr>
        <p:xfrm>
          <a:off x="395536" y="2204864"/>
          <a:ext cx="8352930" cy="2834718"/>
        </p:xfrm>
        <a:graphic>
          <a:graphicData uri="http://schemas.openxmlformats.org/drawingml/2006/table">
            <a:tbl>
              <a:tblPr/>
              <a:tblGrid>
                <a:gridCol w="324259"/>
                <a:gridCol w="505845"/>
                <a:gridCol w="118686"/>
                <a:gridCol w="309337"/>
                <a:gridCol w="244124"/>
                <a:gridCol w="261722"/>
                <a:gridCol w="291739"/>
                <a:gridCol w="79066"/>
                <a:gridCol w="212862"/>
                <a:gridCol w="340599"/>
                <a:gridCol w="243069"/>
                <a:gridCol w="389458"/>
                <a:gridCol w="194209"/>
                <a:gridCol w="359252"/>
                <a:gridCol w="1027856"/>
                <a:gridCol w="1027856"/>
                <a:gridCol w="553461"/>
                <a:gridCol w="92587"/>
                <a:gridCol w="698072"/>
                <a:gridCol w="1078871"/>
              </a:tblGrid>
              <a:tr h="180368"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2430">
                <a:tc rowSpan="3">
                  <a:txBody>
                    <a:bodyPr/>
                    <a:lstStyle/>
                    <a:p>
                      <a:pPr algn="ctr" fontAlgn="b"/>
                      <a:r>
                        <a:rPr lang="ja-JP" alt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　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13">
                  <a:txBody>
                    <a:bodyPr/>
                    <a:lstStyle/>
                    <a:p>
                      <a:pPr algn="ctr" fontAlgn="ctr"/>
                      <a:r>
                        <a:rPr lang="en-US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asured chromaticity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chelson</a:t>
                      </a:r>
                      <a:br>
                        <a:rPr lang="en-US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</a:br>
                      <a:r>
                        <a:rPr lang="en-US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as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⊿E(CIEL*a*b*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 gridSpan="3">
                  <a:txBody>
                    <a:bodyPr/>
                    <a:lstStyle/>
                    <a:p>
                      <a:pPr algn="ctr" fontAlgn="ctr"/>
                      <a:r>
                        <a:rPr lang="en-US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eoretical target</a:t>
                      </a:r>
                      <a:br>
                        <a:rPr lang="en-US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</a:br>
                      <a:r>
                        <a:rPr lang="en-US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omaticity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⊿E(CIEL*a*b*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6546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ckground(D65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endParaRPr kumimoji="1" lang="ja-JP" altLang="en-US" sz="1500"/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-US" sz="1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andolt's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ring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24243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381474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ja-JP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2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ja-JP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ja-JP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.1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ja-JP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ja-JP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.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ja-JP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.0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966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.4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.5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ja-JP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.5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36004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G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ja-JP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2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ja-JP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ja-JP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.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500" dirty="0"/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ja-JP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9.9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ja-JP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ja-JP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.5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7332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.7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7.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ja-JP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8.9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.6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6004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P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ja-JP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2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ja-JP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ja-JP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0.8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500" dirty="0"/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ja-JP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8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ja-JP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9.7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ja-JP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066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.1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ja-JP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6.9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.6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6004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Y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ja-JP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3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ja-JP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ja-JP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0.5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500"/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ja-JP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7.8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ja-JP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9.8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ja-JP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.3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4561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.4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6.7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ja-JP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.7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.5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2430">
                <a:tc>
                  <a:txBody>
                    <a:bodyPr/>
                    <a:lstStyle/>
                    <a:p>
                      <a:pPr algn="l" fontAlgn="b"/>
                      <a:endParaRPr lang="ja-JP" altLang="en-US" sz="1500" b="0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ja-JP" altLang="en-US" sz="1500" b="0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endParaRPr kumimoji="1" lang="ja-JP" altLang="en-US" sz="1500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endParaRPr kumimoji="1" lang="ja-JP" altLang="en-US" sz="1500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500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endParaRPr kumimoji="1" lang="ja-JP" altLang="en-US" sz="1500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endParaRPr kumimoji="1" lang="ja-JP" altLang="en-US" sz="1500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endParaRPr kumimoji="1" lang="ja-JP" altLang="en-US" sz="1500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endParaRPr kumimoji="1" lang="ja-JP" altLang="en-US" sz="1500" dirty="0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005458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9</TotalTime>
  <Words>95</Words>
  <Application>Microsoft Office PowerPoint</Application>
  <PresentationFormat>画面に合わせる (4:3)</PresentationFormat>
  <Paragraphs>65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1_Office テーマ</vt:lpstr>
      <vt:lpstr>Supplementary Table S1. Characteristics of chromaticity, delta and Michelson contrast    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Table S1. Characteristics of chromaticity, delta and Michelson contrast</dc:title>
  <dc:creator>Kunikata MD PhD</dc:creator>
  <cp:lastModifiedBy>Kunikata MD PhD</cp:lastModifiedBy>
  <cp:revision>3</cp:revision>
  <dcterms:created xsi:type="dcterms:W3CDTF">2018-11-20T09:54:35Z</dcterms:created>
  <dcterms:modified xsi:type="dcterms:W3CDTF">2019-02-12T06:42:13Z</dcterms:modified>
</cp:coreProperties>
</file>